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88163" cy="100187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36" autoAdjust="0"/>
    <p:restoredTop sz="94660"/>
  </p:normalViewPr>
  <p:slideViewPr>
    <p:cSldViewPr snapToGrid="0">
      <p:cViewPr>
        <p:scale>
          <a:sx n="100" d="100"/>
          <a:sy n="100" d="100"/>
        </p:scale>
        <p:origin x="1416" y="-2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51312;&#54788;&#46041;\Desktop\&#48156;&#54952;&#44260;&#52649;&#51032;%20&#44036;&#50516;&#49464;&#54252;%20&#49324;&#47736;&#54952;&#44284;%20(SCI)\&#44208;&#44284;\&#48156;&#54952;&#44260;&#52649;%20screen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48594159054603"/>
          <c:y val="5.0925925925925923E-2"/>
          <c:w val="0.8629769013056664"/>
          <c:h val="0.790543890347039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M$91</c:f>
              <c:strCache>
                <c:ptCount val="1"/>
                <c:pt idx="0">
                  <c:v>Water extract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29:$X$29</c:f>
                <c:numCache>
                  <c:formatCode>General</c:formatCode>
                  <c:ptCount val="22"/>
                  <c:pt idx="0">
                    <c:v>3.28</c:v>
                  </c:pt>
                  <c:pt idx="1">
                    <c:v>3.76</c:v>
                  </c:pt>
                  <c:pt idx="2">
                    <c:v>3.4</c:v>
                  </c:pt>
                  <c:pt idx="3">
                    <c:v>5</c:v>
                  </c:pt>
                  <c:pt idx="4">
                    <c:v>2.35</c:v>
                  </c:pt>
                  <c:pt idx="5">
                    <c:v>1.76</c:v>
                  </c:pt>
                  <c:pt idx="6">
                    <c:v>5.48</c:v>
                  </c:pt>
                  <c:pt idx="7">
                    <c:v>6.23</c:v>
                  </c:pt>
                  <c:pt idx="8">
                    <c:v>5.4</c:v>
                  </c:pt>
                  <c:pt idx="9">
                    <c:v>4.29</c:v>
                  </c:pt>
                  <c:pt idx="10">
                    <c:v>3.4</c:v>
                  </c:pt>
                  <c:pt idx="11">
                    <c:v>5</c:v>
                  </c:pt>
                  <c:pt idx="12">
                    <c:v>5.55</c:v>
                  </c:pt>
                  <c:pt idx="13">
                    <c:v>5</c:v>
                  </c:pt>
                  <c:pt idx="14">
                    <c:v>2.2999999999999998</c:v>
                  </c:pt>
                  <c:pt idx="15">
                    <c:v>4.4000000000000004</c:v>
                  </c:pt>
                  <c:pt idx="16">
                    <c:v>6.7</c:v>
                  </c:pt>
                  <c:pt idx="17">
                    <c:v>2.8</c:v>
                  </c:pt>
                  <c:pt idx="18">
                    <c:v>5</c:v>
                  </c:pt>
                  <c:pt idx="19">
                    <c:v>4.3099999999999996</c:v>
                  </c:pt>
                  <c:pt idx="20">
                    <c:v>7</c:v>
                  </c:pt>
                  <c:pt idx="21">
                    <c:v>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37:$U$37</c:f>
              <c:strCache>
                <c:ptCount val="8"/>
                <c:pt idx="0">
                  <c:v>Control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strCache>
            </c:strRef>
          </c:cat>
          <c:val>
            <c:numRef>
              <c:f>(Sheet1!$R$33,Sheet1!$R$28:$X$28)</c:f>
              <c:numCache>
                <c:formatCode>General</c:formatCode>
                <c:ptCount val="8"/>
                <c:pt idx="0">
                  <c:v>100</c:v>
                </c:pt>
                <c:pt idx="1">
                  <c:v>92.37</c:v>
                </c:pt>
                <c:pt idx="2">
                  <c:v>101.27</c:v>
                </c:pt>
                <c:pt idx="3">
                  <c:v>94.2376</c:v>
                </c:pt>
                <c:pt idx="4">
                  <c:v>96.2376</c:v>
                </c:pt>
                <c:pt idx="5">
                  <c:v>102.69</c:v>
                </c:pt>
                <c:pt idx="6">
                  <c:v>97.19</c:v>
                </c:pt>
                <c:pt idx="7">
                  <c:v>98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00-4DE8-B229-819EB4D74933}"/>
            </c:ext>
          </c:extLst>
        </c:ser>
        <c:ser>
          <c:idx val="1"/>
          <c:order val="1"/>
          <c:tx>
            <c:strRef>
              <c:f>Sheet1!$N$91</c:f>
              <c:strCache>
                <c:ptCount val="1"/>
                <c:pt idx="0">
                  <c:v>EtOH extract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C$29,Sheet1!$D$32:$W$32,Sheet1!$W$32)</c:f>
                <c:numCache>
                  <c:formatCode>General</c:formatCode>
                  <c:ptCount val="22"/>
                  <c:pt idx="0">
                    <c:v>3.28</c:v>
                  </c:pt>
                  <c:pt idx="1">
                    <c:v>5</c:v>
                  </c:pt>
                  <c:pt idx="2">
                    <c:v>3</c:v>
                  </c:pt>
                  <c:pt idx="3">
                    <c:v>5.48</c:v>
                  </c:pt>
                  <c:pt idx="4">
                    <c:v>6.23</c:v>
                  </c:pt>
                  <c:pt idx="5">
                    <c:v>2.2999999999999998</c:v>
                  </c:pt>
                  <c:pt idx="6">
                    <c:v>5</c:v>
                  </c:pt>
                  <c:pt idx="7">
                    <c:v>6</c:v>
                  </c:pt>
                  <c:pt idx="8">
                    <c:v>3</c:v>
                  </c:pt>
                  <c:pt idx="9">
                    <c:v>5.4</c:v>
                  </c:pt>
                  <c:pt idx="10">
                    <c:v>5.12</c:v>
                  </c:pt>
                  <c:pt idx="11">
                    <c:v>4.29</c:v>
                  </c:pt>
                  <c:pt idx="12">
                    <c:v>7.2</c:v>
                  </c:pt>
                  <c:pt idx="13">
                    <c:v>3.98</c:v>
                  </c:pt>
                  <c:pt idx="14">
                    <c:v>6</c:v>
                  </c:pt>
                  <c:pt idx="15">
                    <c:v>6.23</c:v>
                  </c:pt>
                  <c:pt idx="16">
                    <c:v>2.9</c:v>
                  </c:pt>
                  <c:pt idx="17">
                    <c:v>3.4</c:v>
                  </c:pt>
                  <c:pt idx="18">
                    <c:v>5</c:v>
                  </c:pt>
                  <c:pt idx="19">
                    <c:v>3.33</c:v>
                  </c:pt>
                  <c:pt idx="20">
                    <c:v>4.18</c:v>
                  </c:pt>
                  <c:pt idx="21">
                    <c:v>4.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37:$U$37</c:f>
              <c:strCache>
                <c:ptCount val="8"/>
                <c:pt idx="0">
                  <c:v>Control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strCache>
            </c:strRef>
          </c:cat>
          <c:val>
            <c:numRef>
              <c:f>(Sheet1!$R$34,Sheet1!$R$31:$X$31)</c:f>
              <c:numCache>
                <c:formatCode>General</c:formatCode>
                <c:ptCount val="8"/>
                <c:pt idx="0">
                  <c:v>100</c:v>
                </c:pt>
                <c:pt idx="1">
                  <c:v>100.376</c:v>
                </c:pt>
                <c:pt idx="2">
                  <c:v>97.12</c:v>
                </c:pt>
                <c:pt idx="3">
                  <c:v>96.45</c:v>
                </c:pt>
                <c:pt idx="4">
                  <c:v>89.37</c:v>
                </c:pt>
                <c:pt idx="5">
                  <c:v>15.36</c:v>
                </c:pt>
                <c:pt idx="6">
                  <c:v>66.135999999999996</c:v>
                </c:pt>
                <c:pt idx="7">
                  <c:v>89.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00-4DE8-B229-819EB4D749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345327967"/>
        <c:axId val="343951039"/>
      </c:barChart>
      <c:catAx>
        <c:axId val="345327967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43951039"/>
        <c:crosses val="autoZero"/>
        <c:auto val="1"/>
        <c:lblAlgn val="ctr"/>
        <c:lblOffset val="100"/>
        <c:noMultiLvlLbl val="0"/>
      </c:catAx>
      <c:valAx>
        <c:axId val="343951039"/>
        <c:scaling>
          <c:orientation val="minMax"/>
          <c:max val="14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ell viability (%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1.95505465316787E-2"/>
              <c:y val="0.293272367134465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45327967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54483513297387276"/>
          <c:y val="6.076334208223972E-2"/>
          <c:w val="0.4318688358999061"/>
          <c:h val="9.18690449598596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2821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3259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1444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03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6551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7534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3554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149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9934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0943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9382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4C11E6-B65B-4D7B-8A79-66A826D9A87C}" type="datetimeFigureOut">
              <a:rPr lang="ko-KR" altLang="en-US" smtClean="0"/>
              <a:t>2019-07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6782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895825" y="3735991"/>
            <a:ext cx="5349239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</a:t>
            </a: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growth inhibitory effects on HepG2 hepatocellular carcinoma cells treated with </a:t>
            </a:r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0 µg/mL of fermented silkworm larvae water and ethanol extract for 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 h. </a:t>
            </a:r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was measured by SRB assay. 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values were expressed as </a:t>
            </a:r>
            <a:r>
              <a:rPr lang="en-US" altLang="ko-KR" sz="10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n±SD</a:t>
            </a:r>
            <a:r>
              <a:rPr lang="en-US" altLang="ko-KR" sz="1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triplicate determinations. 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differences were compared with the control at *p&lt;0.05, **p&lt;0.01, and ***p&lt;0.001 using one-way ANOVA</a:t>
            </a:r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 Unfermented silkworm larvae</a:t>
            </a:r>
          </a:p>
          <a:p>
            <a:pPr algn="just"/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Fermented silkworm larvae by </a:t>
            </a:r>
            <a:r>
              <a:rPr lang="en-US" altLang="ko-KR" sz="1000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n-US" altLang="ko-KR" sz="1000" i="1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arum</a:t>
            </a:r>
            <a:r>
              <a:rPr lang="en-US" altLang="ko-KR" sz="1000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BMI F3</a:t>
            </a:r>
          </a:p>
          <a:p>
            <a:pPr lvl="0" algn="just"/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</a:t>
            </a:r>
            <a:r>
              <a:rPr lang="en-US" altLang="ko-KR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rmented silkworm larvae by </a:t>
            </a:r>
            <a:r>
              <a:rPr lang="en-US" altLang="ko-KR" sz="1000" i="1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n-US" altLang="ko-KR" sz="1000" i="1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arum</a:t>
            </a:r>
            <a:r>
              <a:rPr lang="en-US" altLang="ko-KR" sz="1000" i="1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BMI </a:t>
            </a:r>
            <a:r>
              <a:rPr lang="en-US" altLang="ko-KR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5</a:t>
            </a:r>
            <a:endParaRPr lang="en-US" altLang="ko-KR" sz="1000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r>
              <a:rPr lang="en-US" altLang="ko-KR" sz="1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 </a:t>
            </a:r>
            <a:r>
              <a:rPr lang="en-US" altLang="ko-KR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rmented silkworm larvae by </a:t>
            </a:r>
            <a:r>
              <a:rPr lang="en-US" altLang="ko-KR" sz="1000" i="1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n-US" altLang="ko-KR" sz="1000" i="1" kern="1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sseri</a:t>
            </a:r>
            <a:r>
              <a:rPr lang="en-US" altLang="ko-KR" sz="1000" i="1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9</a:t>
            </a:r>
            <a:endParaRPr lang="en-US" altLang="ko-KR" sz="1000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r>
              <a:rPr lang="en-US" altLang="ko-KR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: </a:t>
            </a:r>
            <a:r>
              <a:rPr lang="en-US" altLang="ko-KR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rmented silkworm larvae by </a:t>
            </a:r>
            <a:r>
              <a:rPr lang="en-US" altLang="ko-KR" sz="1000" i="1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pergillus </a:t>
            </a:r>
            <a:r>
              <a:rPr lang="en-US" altLang="ko-KR" sz="1000" i="1" kern="1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awachii</a:t>
            </a:r>
            <a:endParaRPr lang="en-US" altLang="ko-KR" sz="1000" i="1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r>
              <a:rPr lang="en-US" altLang="ko-KR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: </a:t>
            </a:r>
            <a:r>
              <a:rPr lang="en-US" altLang="ko-KR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rmented silkworm larvae by </a:t>
            </a:r>
            <a:r>
              <a:rPr lang="en-US" altLang="ko-KR" sz="1000" i="1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ccharomyces cerevisiae </a:t>
            </a:r>
            <a:r>
              <a:rPr lang="en-US" altLang="ko-KR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ACC 93023</a:t>
            </a:r>
            <a:endParaRPr lang="en-US" altLang="ko-KR" sz="1000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r>
              <a:rPr lang="en-US" altLang="ko-KR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: </a:t>
            </a:r>
            <a:r>
              <a:rPr lang="en-US" altLang="ko-KR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rmented silkworm larvae by </a:t>
            </a:r>
            <a:r>
              <a:rPr lang="en-US" altLang="ko-KR" sz="1000" i="1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illus subtilis </a:t>
            </a:r>
            <a:r>
              <a:rPr lang="en-US" altLang="ko-KR" sz="1000" kern="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ACC 91157</a:t>
            </a:r>
            <a:endParaRPr lang="en-US" altLang="ko-KR" sz="1000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59194" y="1396447"/>
            <a:ext cx="4043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ko-KR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4698761" y="1541631"/>
            <a:ext cx="12519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 rot="5400000">
            <a:off x="4651730" y="1588662"/>
            <a:ext cx="9406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 rot="5400000">
            <a:off x="4165664" y="2199926"/>
            <a:ext cx="131658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151393" y="1463220"/>
            <a:ext cx="4043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 smtClean="0">
                <a:latin typeface="Times New Roman" pitchFamily="18" charset="0"/>
                <a:cs typeface="Times New Roman" pitchFamily="18" charset="0"/>
              </a:rPr>
              <a:t>**</a:t>
            </a:r>
            <a:endParaRPr lang="ko-KR" altLang="en-US" sz="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>
            <a:off x="5290960" y="1608404"/>
            <a:ext cx="12519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 rot="5400000">
            <a:off x="5243929" y="1655435"/>
            <a:ext cx="9406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>
          <a:xfrm rot="5400000">
            <a:off x="5136977" y="1887585"/>
            <a:ext cx="55836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" name="차트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9969625"/>
              </p:ext>
            </p:extLst>
          </p:nvPr>
        </p:nvGraphicFramePr>
        <p:xfrm>
          <a:off x="741270" y="1031979"/>
          <a:ext cx="5644290" cy="27040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765034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3</TotalTime>
  <Words>135</Words>
  <Application>Microsoft Office PowerPoint</Application>
  <PresentationFormat>A4 용지(210x297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조현동</dc:creator>
  <cp:lastModifiedBy>조현동</cp:lastModifiedBy>
  <cp:revision>73</cp:revision>
  <cp:lastPrinted>2018-08-16T07:14:38Z</cp:lastPrinted>
  <dcterms:created xsi:type="dcterms:W3CDTF">2018-07-05T12:01:46Z</dcterms:created>
  <dcterms:modified xsi:type="dcterms:W3CDTF">2019-07-16T02:34:35Z</dcterms:modified>
</cp:coreProperties>
</file>